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57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6713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4567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4664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94219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5976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51522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0286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5046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1308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2221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9824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8F09A7-826E-4783-97C9-DDBB3E0CEB9A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6E29E-CE9D-4A08-A851-1F92DF1862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8216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LpnPI_BioRad 2014-05-08 16hr 41min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192" t="14685" r="37870" b="18525"/>
          <a:stretch/>
        </p:blipFill>
        <p:spPr bwMode="auto">
          <a:xfrm>
            <a:off x="7376344" y="2762258"/>
            <a:ext cx="1638300" cy="2624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 rot="18000000">
            <a:off x="7961671" y="1958962"/>
            <a:ext cx="1333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>
                <a:latin typeface="Arial" pitchFamily="34" charset="0"/>
                <a:cs typeface="Arial" pitchFamily="34" charset="0"/>
              </a:rPr>
              <a:t>KIT27-37</a:t>
            </a:r>
          </a:p>
        </p:txBody>
      </p:sp>
      <p:sp>
        <p:nvSpPr>
          <p:cNvPr id="6" name="TextBox 5"/>
          <p:cNvSpPr txBox="1"/>
          <p:nvPr/>
        </p:nvSpPr>
        <p:spPr>
          <a:xfrm rot="18000000">
            <a:off x="7564218" y="2043908"/>
            <a:ext cx="11552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>
                <a:latin typeface="Arial" pitchFamily="34" charset="0"/>
                <a:cs typeface="Arial" pitchFamily="34" charset="0"/>
              </a:rPr>
              <a:t>KIT1-1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917254" y="2864468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2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917254" y="3101398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>
                <a:latin typeface="Arial" pitchFamily="34" charset="0"/>
                <a:cs typeface="Arial" pitchFamily="34" charset="0"/>
              </a:rPr>
              <a:t>1</a:t>
            </a:r>
            <a:r>
              <a:rPr lang="en-AU" sz="1400" dirty="0" smtClean="0">
                <a:latin typeface="Arial" pitchFamily="34" charset="0"/>
                <a:cs typeface="Arial" pitchFamily="34" charset="0"/>
              </a:rPr>
              <a:t>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773238" y="3579433"/>
            <a:ext cx="58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531124" y="4113713"/>
            <a:ext cx="827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2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782644" y="4781503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1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8000000">
            <a:off x="4549787" y="2130335"/>
            <a:ext cx="1105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1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8000000">
            <a:off x="4105254" y="2116387"/>
            <a:ext cx="11552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7.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4436824" y="2056947"/>
            <a:ext cx="83154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328451" y="1718393"/>
            <a:ext cx="11164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>
                <a:latin typeface="Arial" pitchFamily="34" charset="0"/>
                <a:cs typeface="Arial" pitchFamily="34" charset="0"/>
              </a:rPr>
              <a:t>KIT1-1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45962" y="2877957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2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45962" y="3114887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>
                <a:latin typeface="Arial" pitchFamily="34" charset="0"/>
                <a:cs typeface="Arial" pitchFamily="34" charset="0"/>
              </a:rPr>
              <a:t>1</a:t>
            </a:r>
            <a:r>
              <a:rPr lang="en-AU" sz="1400" dirty="0" smtClean="0">
                <a:latin typeface="Arial" pitchFamily="34" charset="0"/>
                <a:cs typeface="Arial" pitchFamily="34" charset="0"/>
              </a:rPr>
              <a:t>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301946" y="3592922"/>
            <a:ext cx="58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059832" y="4166665"/>
            <a:ext cx="827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2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311352" y="479499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1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>
            <a:off x="5363941" y="2056947"/>
            <a:ext cx="79208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255568" y="1718393"/>
            <a:ext cx="1267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 smtClean="0">
                <a:latin typeface="Arial" pitchFamily="34" charset="0"/>
                <a:cs typeface="Arial" pitchFamily="34" charset="0"/>
              </a:rPr>
              <a:t>KIT27-37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8000000">
            <a:off x="5413883" y="2130336"/>
            <a:ext cx="1105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1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8000000">
            <a:off x="4969350" y="2116388"/>
            <a:ext cx="11552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7.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16229" y="1027410"/>
            <a:ext cx="5348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AU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419872" y="1027410"/>
            <a:ext cx="5348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AU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AU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2" descr="E:\From old gel doc computer\hs_Rochekit_MFLdigested.bmp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97" t="19717" r="65173" b="41127"/>
          <a:stretch/>
        </p:blipFill>
        <p:spPr bwMode="auto">
          <a:xfrm>
            <a:off x="598095" y="2728163"/>
            <a:ext cx="2533745" cy="2645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205602" y="2794203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2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05602" y="3031133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>
                <a:latin typeface="Arial" pitchFamily="34" charset="0"/>
                <a:cs typeface="Arial" pitchFamily="34" charset="0"/>
              </a:rPr>
              <a:t>1</a:t>
            </a:r>
            <a:r>
              <a:rPr lang="en-AU" sz="1400" dirty="0" smtClean="0">
                <a:latin typeface="Arial" pitchFamily="34" charset="0"/>
                <a:cs typeface="Arial" pitchFamily="34" charset="0"/>
              </a:rPr>
              <a:t>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1586" y="3509168"/>
            <a:ext cx="58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-180528" y="3991158"/>
            <a:ext cx="827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2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0992" y="471123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1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3" name="Picture 2" descr="E:\From old gel doc computer\hs_Rochekit_MFLdigested.bmp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22" t="19717" r="42583" b="44231"/>
          <a:stretch/>
        </p:blipFill>
        <p:spPr bwMode="auto">
          <a:xfrm>
            <a:off x="3857653" y="2761830"/>
            <a:ext cx="2730082" cy="2636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6879820" y="980728"/>
            <a:ext cx="5348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en-AU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000000">
            <a:off x="1302678" y="2105009"/>
            <a:ext cx="1105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1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8000000">
            <a:off x="858145" y="2091061"/>
            <a:ext cx="11552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7.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Straight Connector 56"/>
          <p:cNvCxnSpPr/>
          <p:nvPr/>
        </p:nvCxnSpPr>
        <p:spPr>
          <a:xfrm>
            <a:off x="1189715" y="2031621"/>
            <a:ext cx="83154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1081342" y="1693067"/>
            <a:ext cx="11164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>
                <a:latin typeface="Arial" pitchFamily="34" charset="0"/>
                <a:cs typeface="Arial" pitchFamily="34" charset="0"/>
              </a:rPr>
              <a:t>KIT1-10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2116832" y="2031621"/>
            <a:ext cx="79208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2008459" y="1693067"/>
            <a:ext cx="1267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600" dirty="0" smtClean="0">
                <a:latin typeface="Arial" pitchFamily="34" charset="0"/>
                <a:cs typeface="Arial" pitchFamily="34" charset="0"/>
              </a:rPr>
              <a:t>KIT27-37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8000000">
            <a:off x="2166774" y="2105010"/>
            <a:ext cx="1105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1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8000000">
            <a:off x="1722241" y="2091062"/>
            <a:ext cx="11552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7.5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884368" y="1268760"/>
            <a:ext cx="9151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>
                <a:latin typeface="Arial" pitchFamily="34" charset="0"/>
                <a:cs typeface="Arial" pitchFamily="34" charset="0"/>
              </a:rPr>
              <a:t>60 µM</a:t>
            </a:r>
            <a:endParaRPr lang="en-AU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7956376" y="1628329"/>
            <a:ext cx="79208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67544" y="260648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dditional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ile 5 </a:t>
            </a:r>
            <a:endParaRPr lang="en-AU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96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63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shi Shinozuka</dc:creator>
  <cp:lastModifiedBy>Hiroshi Shinozuka</cp:lastModifiedBy>
  <cp:revision>15</cp:revision>
  <dcterms:created xsi:type="dcterms:W3CDTF">2014-05-05T02:53:12Z</dcterms:created>
  <dcterms:modified xsi:type="dcterms:W3CDTF">2015-02-11T04:17:50Z</dcterms:modified>
</cp:coreProperties>
</file>